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137"/>
    <p:restoredTop sz="94646"/>
  </p:normalViewPr>
  <p:slideViewPr>
    <p:cSldViewPr snapToGrid="0">
      <p:cViewPr varScale="1">
        <p:scale>
          <a:sx n="89" d="100"/>
          <a:sy n="89" d="100"/>
        </p:scale>
        <p:origin x="102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57B785D-2647-B041-BD51-E1546F5DB371}" type="datetimeFigureOut">
              <a:rPr kumimoji="1" lang="ja-JP" altLang="en-US" smtClean="0"/>
              <a:t>2023/8/1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99EF92-EE7D-E842-ACC8-8C009ED368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11395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799EF92-EE7D-E842-ACC8-8C009ED3680E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482302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E218993-6F8F-845D-1E28-9E0032564A7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AFEB0C27-7910-8E68-4FA9-178AD144A79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E8F04F5-6C50-2F1F-B0CD-4D89ACF18D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BF2A3-E21C-EE40-B8E3-494C4FBEF156}" type="datetimeFigureOut">
              <a:rPr kumimoji="1" lang="ja-JP" altLang="en-US" smtClean="0"/>
              <a:t>2023/8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EB45FFA-DFC1-EEEC-18BB-298BFDB9D5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291ABFF-DC34-0E8E-AB39-C53079C107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1336C-DE3C-094C-A6D0-B6ADC8FB4B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84583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9823F89-C2E1-4F6D-C6C1-739D30C137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31B9A97-B6F7-2DDE-B567-023792F8AC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55C1908-6524-A668-22EF-AB635E9604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BF2A3-E21C-EE40-B8E3-494C4FBEF156}" type="datetimeFigureOut">
              <a:rPr kumimoji="1" lang="ja-JP" altLang="en-US" smtClean="0"/>
              <a:t>2023/8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F12F03F-92A4-346A-FFDF-AEF343D924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C45CAA6-0F7C-4E23-2449-0A7F17602F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1336C-DE3C-094C-A6D0-B6ADC8FB4B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12582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01E18E70-A7AA-B4AE-CA14-4E2CA48089D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366416C-3FE3-2BD9-FF83-79DA37D729F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995EE09-F1B4-78F3-3C1F-64AFF5F2C3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BF2A3-E21C-EE40-B8E3-494C4FBEF156}" type="datetimeFigureOut">
              <a:rPr kumimoji="1" lang="ja-JP" altLang="en-US" smtClean="0"/>
              <a:t>2023/8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8533481-7D8D-E914-85B3-3C06DC52F5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0735CA9-CD77-08AF-7A40-6A739E64B3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1336C-DE3C-094C-A6D0-B6ADC8FB4B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92370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981D7B1-1AEE-0630-254F-BDB3C32799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AA2D9B8-AC66-512C-8D47-C1E77C9711C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C977378-B309-5ABD-1CA8-03AF916010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BF2A3-E21C-EE40-B8E3-494C4FBEF156}" type="datetimeFigureOut">
              <a:rPr kumimoji="1" lang="ja-JP" altLang="en-US" smtClean="0"/>
              <a:t>2023/8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284E1FA-1A03-8EA0-6C21-42E4026DA7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1D14D1D-7BA5-96AA-F203-54B12BB1DD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1336C-DE3C-094C-A6D0-B6ADC8FB4B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68678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723BA36-D1A6-950E-3A15-0704DF7A92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6EAAD8F-5984-D08A-C0EB-93306FCFD6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75C74FF-D16A-073E-663D-71E54040F3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BF2A3-E21C-EE40-B8E3-494C4FBEF156}" type="datetimeFigureOut">
              <a:rPr kumimoji="1" lang="ja-JP" altLang="en-US" smtClean="0"/>
              <a:t>2023/8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724F94D-2F48-0B35-E672-FF1DBFF14D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FDB4DD7-B739-D67D-2FD1-873BB9D43C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1336C-DE3C-094C-A6D0-B6ADC8FB4B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27061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F2FF70B-4FA1-009B-E916-E83B603D7A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F030D43-D466-7D70-9D95-F4BF2553FF0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98F7222-EDE8-E39C-D6DA-2D37C1613A7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747E5F1-D9C9-AB56-DDA2-32187A242B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BF2A3-E21C-EE40-B8E3-494C4FBEF156}" type="datetimeFigureOut">
              <a:rPr kumimoji="1" lang="ja-JP" altLang="en-US" smtClean="0"/>
              <a:t>2023/8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C936AA2-CA7B-F48C-9197-E499C2B9B0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69B0EC3-EAC5-77C4-C229-09FDBCB37E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1336C-DE3C-094C-A6D0-B6ADC8FB4B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10541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0DF535D-0FAA-C318-60FF-518753F15C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F27F2B6-EE9A-9F01-EB7C-86A9FC1E55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07D79D9-6A86-8B69-96D3-3F484047681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9B8979DC-751C-9AED-0E76-5DA3FC93051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775E70E9-9E7A-13CE-0317-3F93FCA9805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0618E198-B78E-2C89-3A9C-DCFD471CD9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BF2A3-E21C-EE40-B8E3-494C4FBEF156}" type="datetimeFigureOut">
              <a:rPr kumimoji="1" lang="ja-JP" altLang="en-US" smtClean="0"/>
              <a:t>2023/8/1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8C9C5B69-E339-2E5E-FB3F-9977AE466F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9BB874D5-27AC-825F-E949-9699793155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1336C-DE3C-094C-A6D0-B6ADC8FB4B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03878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C49CF67-9D6A-C8B4-EB70-DCBA0655AE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4A521DBB-15AC-B67F-E6F7-ACB5D94BC9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BF2A3-E21C-EE40-B8E3-494C4FBEF156}" type="datetimeFigureOut">
              <a:rPr kumimoji="1" lang="ja-JP" altLang="en-US" smtClean="0"/>
              <a:t>2023/8/1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0766A057-6EC0-E33D-7287-79A06D2EED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B277C6DF-B84C-627C-0ADD-FF8811B1F8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1336C-DE3C-094C-A6D0-B6ADC8FB4B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85444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69E37CD0-FE9D-FCCF-2DB2-62ABB2C266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BF2A3-E21C-EE40-B8E3-494C4FBEF156}" type="datetimeFigureOut">
              <a:rPr kumimoji="1" lang="ja-JP" altLang="en-US" smtClean="0"/>
              <a:t>2023/8/1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BD8910CC-4228-77BC-6A45-76F3FD1724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2E3C6E40-97B6-FDE3-66EF-DE08234138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1336C-DE3C-094C-A6D0-B6ADC8FB4B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09307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4B52F6E-69C2-F71F-A332-AA417E32FD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C598E8E-0D9E-BA3B-1E7E-FCF252BB7AA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B282FEE-1340-B35E-D8C4-25999081C41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2A34577-CF6E-5BA2-DF92-80B48B4BF0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BF2A3-E21C-EE40-B8E3-494C4FBEF156}" type="datetimeFigureOut">
              <a:rPr kumimoji="1" lang="ja-JP" altLang="en-US" smtClean="0"/>
              <a:t>2023/8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B4951D5-B4FC-0081-FDDC-816893DC74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14FB8B3-FAF0-FC1F-C1E8-130280C59E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1336C-DE3C-094C-A6D0-B6ADC8FB4B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17636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B51F374-B4B6-FDD7-14BB-350EFF76AF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66637429-02CA-2E3A-9C24-137E9F7D5B6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C87EEDF-953A-5E36-192D-330AECA3ACF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AC2CE9F-7CB3-C32D-D4C0-BA90D14578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BF2A3-E21C-EE40-B8E3-494C4FBEF156}" type="datetimeFigureOut">
              <a:rPr kumimoji="1" lang="ja-JP" altLang="en-US" smtClean="0"/>
              <a:t>2023/8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EC63744-8E8C-3B1E-0AAD-26CA84135A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C36B01E-AA2F-F571-6712-305FA32D47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1336C-DE3C-094C-A6D0-B6ADC8FB4B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29631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0C76E01B-F4E1-0755-6A4D-5425C7EDC8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2826E65-4F16-4A72-7E0D-51E59D6179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DF17779-2E1E-A86D-93DF-22F2E14F1F3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CBF2A3-E21C-EE40-B8E3-494C4FBEF156}" type="datetimeFigureOut">
              <a:rPr kumimoji="1" lang="ja-JP" altLang="en-US" smtClean="0"/>
              <a:t>2023/8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3C1962D-0DAB-169F-1EB3-9C52411E52C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3EB6C66-F7A0-30A3-3E7D-CC0CCC1C5A6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71336C-DE3C-094C-A6D0-B6ADC8FB4B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88260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120742F5-0D44-BF3E-BA54-D7B769FC329E}"/>
              </a:ext>
            </a:extLst>
          </p:cNvPr>
          <p:cNvSpPr txBox="1"/>
          <p:nvPr/>
        </p:nvSpPr>
        <p:spPr>
          <a:xfrm>
            <a:off x="6347900" y="5822897"/>
            <a:ext cx="527420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With microdissection (tumor content is higher than 20%)</a:t>
            </a:r>
            <a:endParaRPr kumimoji="1" lang="ja-JP" altLang="en-US" sz="1600">
              <a:latin typeface="Arial" panose="020B0604020202020204" pitchFamily="34" charset="0"/>
              <a:ea typeface="Meiryo UI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2DA89819-B933-6526-B008-E0E8D0D913D7}"/>
              </a:ext>
            </a:extLst>
          </p:cNvPr>
          <p:cNvSpPr txBox="1"/>
          <p:nvPr/>
        </p:nvSpPr>
        <p:spPr>
          <a:xfrm>
            <a:off x="588961" y="5822897"/>
            <a:ext cx="51716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Without microdissection (tumor content is around 10%)</a:t>
            </a:r>
            <a:endParaRPr kumimoji="1" lang="ja-JP" altLang="en-US" sz="1600">
              <a:latin typeface="Arial" panose="020B0604020202020204" pitchFamily="34" charset="0"/>
              <a:ea typeface="Meiryo UI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10" name="テキスト ボックス 8">
            <a:extLst>
              <a:ext uri="{FF2B5EF4-FFF2-40B4-BE49-F238E27FC236}">
                <a16:creationId xmlns:a16="http://schemas.microsoft.com/office/drawing/2014/main" id="{2D710FF0-FD3C-324D-A454-DDA0D68C3DDE}"/>
              </a:ext>
            </a:extLst>
          </p:cNvPr>
          <p:cNvSpPr txBox="1"/>
          <p:nvPr/>
        </p:nvSpPr>
        <p:spPr>
          <a:xfrm>
            <a:off x="975375" y="6265964"/>
            <a:ext cx="102515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Supplementary </a:t>
            </a:r>
            <a:r>
              <a:rPr kumimoji="1" lang="en-US" altLang="ja-JP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Figure </a:t>
            </a:r>
            <a:r>
              <a:rPr lang="en-US" altLang="ja-JP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1.</a:t>
            </a:r>
            <a:r>
              <a:rPr kumimoji="1" lang="en-US" altLang="ja-JP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HE-stained image of with tumor content with and without microdissection.</a:t>
            </a:r>
            <a:endParaRPr kumimoji="1" lang="ja-JP" altLang="en-US">
              <a:latin typeface="Arial" panose="020B0604020202020204" pitchFamily="34" charset="0"/>
              <a:ea typeface="Meiryo UI" panose="020B0604030504040204" pitchFamily="34" charset="-128"/>
              <a:cs typeface="Arial" panose="020B0604020202020204" pitchFamily="34" charset="0"/>
            </a:endParaRPr>
          </a:p>
        </p:txBody>
      </p:sp>
      <p:pic>
        <p:nvPicPr>
          <p:cNvPr id="11" name="図 4">
            <a:extLst>
              <a:ext uri="{FF2B5EF4-FFF2-40B4-BE49-F238E27FC236}">
                <a16:creationId xmlns:a16="http://schemas.microsoft.com/office/drawing/2014/main" id="{F0C8C6B3-F2C2-9740-9A13-7EB0A1DA044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2761" r="20800" b="52"/>
          <a:stretch/>
        </p:blipFill>
        <p:spPr>
          <a:xfrm>
            <a:off x="485775" y="471487"/>
            <a:ext cx="5209062" cy="4859456"/>
          </a:xfrm>
          <a:prstGeom prst="rect">
            <a:avLst/>
          </a:prstGeom>
        </p:spPr>
      </p:pic>
      <p:cxnSp>
        <p:nvCxnSpPr>
          <p:cNvPr id="14" name="直線コネクタ 3">
            <a:extLst>
              <a:ext uri="{FF2B5EF4-FFF2-40B4-BE49-F238E27FC236}">
                <a16:creationId xmlns:a16="http://schemas.microsoft.com/office/drawing/2014/main" id="{20564514-2BBD-F148-B1F1-C4AE1A8FEB4C}"/>
              </a:ext>
            </a:extLst>
          </p:cNvPr>
          <p:cNvCxnSpPr/>
          <p:nvPr/>
        </p:nvCxnSpPr>
        <p:spPr>
          <a:xfrm>
            <a:off x="3218356" y="4969938"/>
            <a:ext cx="2109035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線コネクタ 10">
            <a:extLst>
              <a:ext uri="{FF2B5EF4-FFF2-40B4-BE49-F238E27FC236}">
                <a16:creationId xmlns:a16="http://schemas.microsoft.com/office/drawing/2014/main" id="{031730F3-344B-EC43-9D87-4F0A80AFE0AA}"/>
              </a:ext>
            </a:extLst>
          </p:cNvPr>
          <p:cNvCxnSpPr/>
          <p:nvPr/>
        </p:nvCxnSpPr>
        <p:spPr>
          <a:xfrm>
            <a:off x="3227524" y="4960768"/>
            <a:ext cx="0" cy="150597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線コネクタ 11">
            <a:extLst>
              <a:ext uri="{FF2B5EF4-FFF2-40B4-BE49-F238E27FC236}">
                <a16:creationId xmlns:a16="http://schemas.microsoft.com/office/drawing/2014/main" id="{8492731C-FD88-0447-AECF-6E59C8C45D3F}"/>
              </a:ext>
            </a:extLst>
          </p:cNvPr>
          <p:cNvCxnSpPr/>
          <p:nvPr/>
        </p:nvCxnSpPr>
        <p:spPr>
          <a:xfrm>
            <a:off x="5312106" y="4960768"/>
            <a:ext cx="0" cy="150597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線コネクタ 12">
            <a:extLst>
              <a:ext uri="{FF2B5EF4-FFF2-40B4-BE49-F238E27FC236}">
                <a16:creationId xmlns:a16="http://schemas.microsoft.com/office/drawing/2014/main" id="{1277A95A-6C21-6E44-B8DA-8124888B6757}"/>
              </a:ext>
            </a:extLst>
          </p:cNvPr>
          <p:cNvCxnSpPr/>
          <p:nvPr/>
        </p:nvCxnSpPr>
        <p:spPr>
          <a:xfrm>
            <a:off x="4272874" y="4960768"/>
            <a:ext cx="0" cy="150597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コネクタ 13">
            <a:extLst>
              <a:ext uri="{FF2B5EF4-FFF2-40B4-BE49-F238E27FC236}">
                <a16:creationId xmlns:a16="http://schemas.microsoft.com/office/drawing/2014/main" id="{DA62E53E-1701-244B-9740-E2889D333539}"/>
              </a:ext>
            </a:extLst>
          </p:cNvPr>
          <p:cNvCxnSpPr/>
          <p:nvPr/>
        </p:nvCxnSpPr>
        <p:spPr>
          <a:xfrm>
            <a:off x="4792490" y="4960768"/>
            <a:ext cx="0" cy="150597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線コネクタ 14">
            <a:extLst>
              <a:ext uri="{FF2B5EF4-FFF2-40B4-BE49-F238E27FC236}">
                <a16:creationId xmlns:a16="http://schemas.microsoft.com/office/drawing/2014/main" id="{5A2FD879-527E-4D41-8B6D-5BB58D14F793}"/>
              </a:ext>
            </a:extLst>
          </p:cNvPr>
          <p:cNvCxnSpPr/>
          <p:nvPr/>
        </p:nvCxnSpPr>
        <p:spPr>
          <a:xfrm>
            <a:off x="3774651" y="4960768"/>
            <a:ext cx="0" cy="150597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テキスト ボックス 15">
            <a:extLst>
              <a:ext uri="{FF2B5EF4-FFF2-40B4-BE49-F238E27FC236}">
                <a16:creationId xmlns:a16="http://schemas.microsoft.com/office/drawing/2014/main" id="{57225EDE-3737-C643-8398-15631BE5018D}"/>
              </a:ext>
            </a:extLst>
          </p:cNvPr>
          <p:cNvSpPr txBox="1"/>
          <p:nvPr/>
        </p:nvSpPr>
        <p:spPr>
          <a:xfrm>
            <a:off x="3099149" y="507468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0</a:t>
            </a:r>
            <a:endParaRPr kumimoji="1" lang="ja-JP" altLang="en-US" sz="1400"/>
          </a:p>
        </p:txBody>
      </p:sp>
      <p:sp>
        <p:nvSpPr>
          <p:cNvPr id="21" name="テキスト ボックス 16">
            <a:extLst>
              <a:ext uri="{FF2B5EF4-FFF2-40B4-BE49-F238E27FC236}">
                <a16:creationId xmlns:a16="http://schemas.microsoft.com/office/drawing/2014/main" id="{FC21EEFF-333E-8743-9CC3-8EF1B9CD1B65}"/>
              </a:ext>
            </a:extLst>
          </p:cNvPr>
          <p:cNvSpPr txBox="1"/>
          <p:nvPr/>
        </p:nvSpPr>
        <p:spPr>
          <a:xfrm>
            <a:off x="3553166" y="5074684"/>
            <a:ext cx="431604" cy="3185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0.5</a:t>
            </a:r>
            <a:endParaRPr kumimoji="1" lang="ja-JP" altLang="en-US" sz="1400"/>
          </a:p>
        </p:txBody>
      </p:sp>
      <p:sp>
        <p:nvSpPr>
          <p:cNvPr id="22" name="テキスト ボックス 17">
            <a:extLst>
              <a:ext uri="{FF2B5EF4-FFF2-40B4-BE49-F238E27FC236}">
                <a16:creationId xmlns:a16="http://schemas.microsoft.com/office/drawing/2014/main" id="{484F5019-4D6B-C843-BFE8-2D814F7BB298}"/>
              </a:ext>
            </a:extLst>
          </p:cNvPr>
          <p:cNvSpPr txBox="1"/>
          <p:nvPr/>
        </p:nvSpPr>
        <p:spPr>
          <a:xfrm>
            <a:off x="4139603" y="507468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1</a:t>
            </a:r>
            <a:endParaRPr kumimoji="1" lang="ja-JP" altLang="en-US" sz="1400"/>
          </a:p>
        </p:txBody>
      </p:sp>
      <p:sp>
        <p:nvSpPr>
          <p:cNvPr id="23" name="テキスト ボックス 18">
            <a:extLst>
              <a:ext uri="{FF2B5EF4-FFF2-40B4-BE49-F238E27FC236}">
                <a16:creationId xmlns:a16="http://schemas.microsoft.com/office/drawing/2014/main" id="{382BA7EA-6497-7947-B96E-5A98F74F74B9}"/>
              </a:ext>
            </a:extLst>
          </p:cNvPr>
          <p:cNvSpPr txBox="1"/>
          <p:nvPr/>
        </p:nvSpPr>
        <p:spPr>
          <a:xfrm>
            <a:off x="4596055" y="5077585"/>
            <a:ext cx="431604" cy="3185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1</a:t>
            </a:r>
            <a:r>
              <a:rPr kumimoji="1" lang="en-US" altLang="ja-JP" sz="1400" dirty="0"/>
              <a:t>.5</a:t>
            </a:r>
            <a:endParaRPr kumimoji="1" lang="ja-JP" altLang="en-US" sz="1400"/>
          </a:p>
        </p:txBody>
      </p:sp>
      <p:sp>
        <p:nvSpPr>
          <p:cNvPr id="24" name="テキスト ボックス 19">
            <a:extLst>
              <a:ext uri="{FF2B5EF4-FFF2-40B4-BE49-F238E27FC236}">
                <a16:creationId xmlns:a16="http://schemas.microsoft.com/office/drawing/2014/main" id="{7F7EFD30-0485-6649-AF80-CCB620CC5C8B}"/>
              </a:ext>
            </a:extLst>
          </p:cNvPr>
          <p:cNvSpPr txBox="1"/>
          <p:nvPr/>
        </p:nvSpPr>
        <p:spPr>
          <a:xfrm>
            <a:off x="5175522" y="5078785"/>
            <a:ext cx="612706" cy="3185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2mm</a:t>
            </a:r>
            <a:endParaRPr kumimoji="1" lang="ja-JP" altLang="en-US" sz="1400"/>
          </a:p>
        </p:txBody>
      </p:sp>
      <p:pic>
        <p:nvPicPr>
          <p:cNvPr id="12" name="図 5">
            <a:extLst>
              <a:ext uri="{FF2B5EF4-FFF2-40B4-BE49-F238E27FC236}">
                <a16:creationId xmlns:a16="http://schemas.microsoft.com/office/drawing/2014/main" id="{C4B66225-2421-B844-B5A7-85563CC4970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2761" r="20800" b="52"/>
          <a:stretch/>
        </p:blipFill>
        <p:spPr>
          <a:xfrm>
            <a:off x="6150369" y="500063"/>
            <a:ext cx="5192569" cy="4844070"/>
          </a:xfrm>
          <a:prstGeom prst="rect">
            <a:avLst/>
          </a:prstGeom>
        </p:spPr>
      </p:pic>
      <p:sp>
        <p:nvSpPr>
          <p:cNvPr id="13" name="フリーフォーム 6">
            <a:extLst>
              <a:ext uri="{FF2B5EF4-FFF2-40B4-BE49-F238E27FC236}">
                <a16:creationId xmlns:a16="http://schemas.microsoft.com/office/drawing/2014/main" id="{5F2F81A6-A28E-3D4D-8B55-46607B83BC8C}"/>
              </a:ext>
            </a:extLst>
          </p:cNvPr>
          <p:cNvSpPr/>
          <p:nvPr/>
        </p:nvSpPr>
        <p:spPr>
          <a:xfrm>
            <a:off x="6140749" y="1883993"/>
            <a:ext cx="3261729" cy="2572472"/>
          </a:xfrm>
          <a:custGeom>
            <a:avLst/>
            <a:gdLst>
              <a:gd name="connsiteX0" fmla="*/ 3312171 w 3794084"/>
              <a:gd name="connsiteY0" fmla="*/ 1996 h 2992331"/>
              <a:gd name="connsiteX1" fmla="*/ 3386311 w 3794084"/>
              <a:gd name="connsiteY1" fmla="*/ 88493 h 2992331"/>
              <a:gd name="connsiteX2" fmla="*/ 3460452 w 3794084"/>
              <a:gd name="connsiteY2" fmla="*/ 162634 h 2992331"/>
              <a:gd name="connsiteX3" fmla="*/ 3534593 w 3794084"/>
              <a:gd name="connsiteY3" fmla="*/ 273844 h 2992331"/>
              <a:gd name="connsiteX4" fmla="*/ 3608733 w 3794084"/>
              <a:gd name="connsiteY4" fmla="*/ 385055 h 2992331"/>
              <a:gd name="connsiteX5" fmla="*/ 3633447 w 3794084"/>
              <a:gd name="connsiteY5" fmla="*/ 422126 h 2992331"/>
              <a:gd name="connsiteX6" fmla="*/ 3682874 w 3794084"/>
              <a:gd name="connsiteY6" fmla="*/ 533336 h 2992331"/>
              <a:gd name="connsiteX7" fmla="*/ 3707587 w 3794084"/>
              <a:gd name="connsiteY7" fmla="*/ 607477 h 2992331"/>
              <a:gd name="connsiteX8" fmla="*/ 3719944 w 3794084"/>
              <a:gd name="connsiteY8" fmla="*/ 644547 h 2992331"/>
              <a:gd name="connsiteX9" fmla="*/ 3744657 w 3794084"/>
              <a:gd name="connsiteY9" fmla="*/ 681617 h 2992331"/>
              <a:gd name="connsiteX10" fmla="*/ 3757014 w 3794084"/>
              <a:gd name="connsiteY10" fmla="*/ 731044 h 2992331"/>
              <a:gd name="connsiteX11" fmla="*/ 3781728 w 3794084"/>
              <a:gd name="connsiteY11" fmla="*/ 866969 h 2992331"/>
              <a:gd name="connsiteX12" fmla="*/ 3794084 w 3794084"/>
              <a:gd name="connsiteY12" fmla="*/ 1212958 h 2992331"/>
              <a:gd name="connsiteX13" fmla="*/ 3781728 w 3794084"/>
              <a:gd name="connsiteY13" fmla="*/ 1521877 h 2992331"/>
              <a:gd name="connsiteX14" fmla="*/ 3757014 w 3794084"/>
              <a:gd name="connsiteY14" fmla="*/ 1608374 h 2992331"/>
              <a:gd name="connsiteX15" fmla="*/ 3707587 w 3794084"/>
              <a:gd name="connsiteY15" fmla="*/ 1682515 h 2992331"/>
              <a:gd name="connsiteX16" fmla="*/ 3645803 w 3794084"/>
              <a:gd name="connsiteY16" fmla="*/ 1756655 h 2992331"/>
              <a:gd name="connsiteX17" fmla="*/ 3571663 w 3794084"/>
              <a:gd name="connsiteY17" fmla="*/ 1806082 h 2992331"/>
              <a:gd name="connsiteX18" fmla="*/ 3485166 w 3794084"/>
              <a:gd name="connsiteY18" fmla="*/ 1855509 h 2992331"/>
              <a:gd name="connsiteX19" fmla="*/ 3361598 w 3794084"/>
              <a:gd name="connsiteY19" fmla="*/ 1929650 h 2992331"/>
              <a:gd name="connsiteX20" fmla="*/ 3275101 w 3794084"/>
              <a:gd name="connsiteY20" fmla="*/ 1991434 h 2992331"/>
              <a:gd name="connsiteX21" fmla="*/ 3238030 w 3794084"/>
              <a:gd name="connsiteY21" fmla="*/ 2016147 h 2992331"/>
              <a:gd name="connsiteX22" fmla="*/ 3200960 w 3794084"/>
              <a:gd name="connsiteY22" fmla="*/ 2053217 h 2992331"/>
              <a:gd name="connsiteX23" fmla="*/ 3126820 w 3794084"/>
              <a:gd name="connsiteY23" fmla="*/ 2102644 h 2992331"/>
              <a:gd name="connsiteX24" fmla="*/ 3052679 w 3794084"/>
              <a:gd name="connsiteY24" fmla="*/ 2152071 h 2992331"/>
              <a:gd name="connsiteX25" fmla="*/ 2941468 w 3794084"/>
              <a:gd name="connsiteY25" fmla="*/ 2213855 h 2992331"/>
              <a:gd name="connsiteX26" fmla="*/ 2892041 w 3794084"/>
              <a:gd name="connsiteY26" fmla="*/ 2250926 h 2992331"/>
              <a:gd name="connsiteX27" fmla="*/ 2817901 w 3794084"/>
              <a:gd name="connsiteY27" fmla="*/ 2300353 h 2992331"/>
              <a:gd name="connsiteX28" fmla="*/ 2719047 w 3794084"/>
              <a:gd name="connsiteY28" fmla="*/ 2374493 h 2992331"/>
              <a:gd name="connsiteX29" fmla="*/ 2669620 w 3794084"/>
              <a:gd name="connsiteY29" fmla="*/ 2411563 h 2992331"/>
              <a:gd name="connsiteX30" fmla="*/ 2583122 w 3794084"/>
              <a:gd name="connsiteY30" fmla="*/ 2473347 h 2992331"/>
              <a:gd name="connsiteX31" fmla="*/ 2533695 w 3794084"/>
              <a:gd name="connsiteY31" fmla="*/ 2522774 h 2992331"/>
              <a:gd name="connsiteX32" fmla="*/ 2484268 w 3794084"/>
              <a:gd name="connsiteY32" fmla="*/ 2559844 h 2992331"/>
              <a:gd name="connsiteX33" fmla="*/ 2434841 w 3794084"/>
              <a:gd name="connsiteY33" fmla="*/ 2609271 h 2992331"/>
              <a:gd name="connsiteX34" fmla="*/ 2323630 w 3794084"/>
              <a:gd name="connsiteY34" fmla="*/ 2683412 h 2992331"/>
              <a:gd name="connsiteX35" fmla="*/ 2261847 w 3794084"/>
              <a:gd name="connsiteY35" fmla="*/ 2732839 h 2992331"/>
              <a:gd name="connsiteX36" fmla="*/ 2175349 w 3794084"/>
              <a:gd name="connsiteY36" fmla="*/ 2782266 h 2992331"/>
              <a:gd name="connsiteX37" fmla="*/ 2039425 w 3794084"/>
              <a:gd name="connsiteY37" fmla="*/ 2856407 h 2992331"/>
              <a:gd name="connsiteX38" fmla="*/ 1989998 w 3794084"/>
              <a:gd name="connsiteY38" fmla="*/ 2868763 h 2992331"/>
              <a:gd name="connsiteX39" fmla="*/ 1915857 w 3794084"/>
              <a:gd name="connsiteY39" fmla="*/ 2893477 h 2992331"/>
              <a:gd name="connsiteX40" fmla="*/ 1878787 w 3794084"/>
              <a:gd name="connsiteY40" fmla="*/ 2905834 h 2992331"/>
              <a:gd name="connsiteX41" fmla="*/ 1829360 w 3794084"/>
              <a:gd name="connsiteY41" fmla="*/ 2918190 h 2992331"/>
              <a:gd name="connsiteX42" fmla="*/ 1705793 w 3794084"/>
              <a:gd name="connsiteY42" fmla="*/ 2942904 h 2992331"/>
              <a:gd name="connsiteX43" fmla="*/ 1668722 w 3794084"/>
              <a:gd name="connsiteY43" fmla="*/ 2955261 h 2992331"/>
              <a:gd name="connsiteX44" fmla="*/ 1471014 w 3794084"/>
              <a:gd name="connsiteY44" fmla="*/ 2979974 h 2992331"/>
              <a:gd name="connsiteX45" fmla="*/ 1273306 w 3794084"/>
              <a:gd name="connsiteY45" fmla="*/ 2992331 h 2992331"/>
              <a:gd name="connsiteX46" fmla="*/ 1112668 w 3794084"/>
              <a:gd name="connsiteY46" fmla="*/ 2979974 h 2992331"/>
              <a:gd name="connsiteX47" fmla="*/ 741966 w 3794084"/>
              <a:gd name="connsiteY47" fmla="*/ 2955261 h 2992331"/>
              <a:gd name="connsiteX48" fmla="*/ 643111 w 3794084"/>
              <a:gd name="connsiteY48" fmla="*/ 2942904 h 2992331"/>
              <a:gd name="connsiteX49" fmla="*/ 556614 w 3794084"/>
              <a:gd name="connsiteY49" fmla="*/ 2918190 h 2992331"/>
              <a:gd name="connsiteX50" fmla="*/ 482474 w 3794084"/>
              <a:gd name="connsiteY50" fmla="*/ 2893477 h 2992331"/>
              <a:gd name="connsiteX51" fmla="*/ 445403 w 3794084"/>
              <a:gd name="connsiteY51" fmla="*/ 2868763 h 2992331"/>
              <a:gd name="connsiteX52" fmla="*/ 346549 w 3794084"/>
              <a:gd name="connsiteY52" fmla="*/ 2819336 h 2992331"/>
              <a:gd name="connsiteX53" fmla="*/ 309479 w 3794084"/>
              <a:gd name="connsiteY53" fmla="*/ 2782266 h 2992331"/>
              <a:gd name="connsiteX54" fmla="*/ 247695 w 3794084"/>
              <a:gd name="connsiteY54" fmla="*/ 2695769 h 2992331"/>
              <a:gd name="connsiteX55" fmla="*/ 136484 w 3794084"/>
              <a:gd name="connsiteY55" fmla="*/ 2547488 h 2992331"/>
              <a:gd name="connsiteX56" fmla="*/ 99414 w 3794084"/>
              <a:gd name="connsiteY56" fmla="*/ 2498061 h 2992331"/>
              <a:gd name="connsiteX57" fmla="*/ 74701 w 3794084"/>
              <a:gd name="connsiteY57" fmla="*/ 2423920 h 2992331"/>
              <a:gd name="connsiteX58" fmla="*/ 49987 w 3794084"/>
              <a:gd name="connsiteY58" fmla="*/ 2374493 h 2992331"/>
              <a:gd name="connsiteX59" fmla="*/ 12917 w 3794084"/>
              <a:gd name="connsiteY59" fmla="*/ 2201498 h 2992331"/>
              <a:gd name="connsiteX60" fmla="*/ 12917 w 3794084"/>
              <a:gd name="connsiteY60" fmla="*/ 1793726 h 2992331"/>
              <a:gd name="connsiteX61" fmla="*/ 37630 w 3794084"/>
              <a:gd name="connsiteY61" fmla="*/ 1558947 h 2992331"/>
              <a:gd name="connsiteX62" fmla="*/ 49987 w 3794084"/>
              <a:gd name="connsiteY62" fmla="*/ 1497163 h 2992331"/>
              <a:gd name="connsiteX63" fmla="*/ 74701 w 3794084"/>
              <a:gd name="connsiteY63" fmla="*/ 1423023 h 2992331"/>
              <a:gd name="connsiteX64" fmla="*/ 87057 w 3794084"/>
              <a:gd name="connsiteY64" fmla="*/ 1385953 h 2992331"/>
              <a:gd name="connsiteX65" fmla="*/ 111771 w 3794084"/>
              <a:gd name="connsiteY65" fmla="*/ 1348882 h 2992331"/>
              <a:gd name="connsiteX66" fmla="*/ 161198 w 3794084"/>
              <a:gd name="connsiteY66" fmla="*/ 1262385 h 2992331"/>
              <a:gd name="connsiteX67" fmla="*/ 284766 w 3794084"/>
              <a:gd name="connsiteY67" fmla="*/ 1114104 h 2992331"/>
              <a:gd name="connsiteX68" fmla="*/ 309479 w 3794084"/>
              <a:gd name="connsiteY68" fmla="*/ 1077034 h 2992331"/>
              <a:gd name="connsiteX69" fmla="*/ 358906 w 3794084"/>
              <a:gd name="connsiteY69" fmla="*/ 1039963 h 2992331"/>
              <a:gd name="connsiteX70" fmla="*/ 433047 w 3794084"/>
              <a:gd name="connsiteY70" fmla="*/ 965823 h 2992331"/>
              <a:gd name="connsiteX71" fmla="*/ 556614 w 3794084"/>
              <a:gd name="connsiteY71" fmla="*/ 879326 h 2992331"/>
              <a:gd name="connsiteX72" fmla="*/ 630755 w 3794084"/>
              <a:gd name="connsiteY72" fmla="*/ 829898 h 2992331"/>
              <a:gd name="connsiteX73" fmla="*/ 680182 w 3794084"/>
              <a:gd name="connsiteY73" fmla="*/ 805185 h 2992331"/>
              <a:gd name="connsiteX74" fmla="*/ 717252 w 3794084"/>
              <a:gd name="connsiteY74" fmla="*/ 792828 h 2992331"/>
              <a:gd name="connsiteX75" fmla="*/ 779036 w 3794084"/>
              <a:gd name="connsiteY75" fmla="*/ 755758 h 2992331"/>
              <a:gd name="connsiteX76" fmla="*/ 840820 w 3794084"/>
              <a:gd name="connsiteY76" fmla="*/ 731044 h 2992331"/>
              <a:gd name="connsiteX77" fmla="*/ 890247 w 3794084"/>
              <a:gd name="connsiteY77" fmla="*/ 693974 h 2992331"/>
              <a:gd name="connsiteX78" fmla="*/ 939674 w 3794084"/>
              <a:gd name="connsiteY78" fmla="*/ 669261 h 2992331"/>
              <a:gd name="connsiteX79" fmla="*/ 1013814 w 3794084"/>
              <a:gd name="connsiteY79" fmla="*/ 619834 h 2992331"/>
              <a:gd name="connsiteX80" fmla="*/ 1063241 w 3794084"/>
              <a:gd name="connsiteY80" fmla="*/ 595120 h 2992331"/>
              <a:gd name="connsiteX81" fmla="*/ 1100311 w 3794084"/>
              <a:gd name="connsiteY81" fmla="*/ 558050 h 2992331"/>
              <a:gd name="connsiteX82" fmla="*/ 1211522 w 3794084"/>
              <a:gd name="connsiteY82" fmla="*/ 508623 h 2992331"/>
              <a:gd name="connsiteX83" fmla="*/ 1322733 w 3794084"/>
              <a:gd name="connsiteY83" fmla="*/ 471553 h 2992331"/>
              <a:gd name="connsiteX84" fmla="*/ 1458657 w 3794084"/>
              <a:gd name="connsiteY84" fmla="*/ 422126 h 2992331"/>
              <a:gd name="connsiteX85" fmla="*/ 1532798 w 3794084"/>
              <a:gd name="connsiteY85" fmla="*/ 397412 h 2992331"/>
              <a:gd name="connsiteX86" fmla="*/ 1582225 w 3794084"/>
              <a:gd name="connsiteY86" fmla="*/ 372698 h 2992331"/>
              <a:gd name="connsiteX87" fmla="*/ 1619295 w 3794084"/>
              <a:gd name="connsiteY87" fmla="*/ 347985 h 2992331"/>
              <a:gd name="connsiteX88" fmla="*/ 1705793 w 3794084"/>
              <a:gd name="connsiteY88" fmla="*/ 323271 h 2992331"/>
              <a:gd name="connsiteX89" fmla="*/ 1742863 w 3794084"/>
              <a:gd name="connsiteY89" fmla="*/ 310915 h 2992331"/>
              <a:gd name="connsiteX90" fmla="*/ 1841717 w 3794084"/>
              <a:gd name="connsiteY90" fmla="*/ 286201 h 2992331"/>
              <a:gd name="connsiteX91" fmla="*/ 1940571 w 3794084"/>
              <a:gd name="connsiteY91" fmla="*/ 249131 h 2992331"/>
              <a:gd name="connsiteX92" fmla="*/ 1989998 w 3794084"/>
              <a:gd name="connsiteY92" fmla="*/ 236774 h 2992331"/>
              <a:gd name="connsiteX93" fmla="*/ 2113566 w 3794084"/>
              <a:gd name="connsiteY93" fmla="*/ 212061 h 2992331"/>
              <a:gd name="connsiteX94" fmla="*/ 2150636 w 3794084"/>
              <a:gd name="connsiteY94" fmla="*/ 199704 h 2992331"/>
              <a:gd name="connsiteX95" fmla="*/ 2286560 w 3794084"/>
              <a:gd name="connsiteY95" fmla="*/ 174990 h 2992331"/>
              <a:gd name="connsiteX96" fmla="*/ 2323630 w 3794084"/>
              <a:gd name="connsiteY96" fmla="*/ 162634 h 2992331"/>
              <a:gd name="connsiteX97" fmla="*/ 2410128 w 3794084"/>
              <a:gd name="connsiteY97" fmla="*/ 150277 h 2992331"/>
              <a:gd name="connsiteX98" fmla="*/ 2558409 w 3794084"/>
              <a:gd name="connsiteY98" fmla="*/ 125563 h 2992331"/>
              <a:gd name="connsiteX99" fmla="*/ 2632549 w 3794084"/>
              <a:gd name="connsiteY99" fmla="*/ 113207 h 2992331"/>
              <a:gd name="connsiteX100" fmla="*/ 2731403 w 3794084"/>
              <a:gd name="connsiteY100" fmla="*/ 100850 h 2992331"/>
              <a:gd name="connsiteX101" fmla="*/ 2854971 w 3794084"/>
              <a:gd name="connsiteY101" fmla="*/ 88493 h 2992331"/>
              <a:gd name="connsiteX102" fmla="*/ 3052679 w 3794084"/>
              <a:gd name="connsiteY102" fmla="*/ 63780 h 2992331"/>
              <a:gd name="connsiteX103" fmla="*/ 3114463 w 3794084"/>
              <a:gd name="connsiteY103" fmla="*/ 51423 h 2992331"/>
              <a:gd name="connsiteX104" fmla="*/ 3213317 w 3794084"/>
              <a:gd name="connsiteY104" fmla="*/ 26709 h 2992331"/>
              <a:gd name="connsiteX105" fmla="*/ 3312171 w 3794084"/>
              <a:gd name="connsiteY105" fmla="*/ 1996 h 299233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</a:cxnLst>
            <a:rect l="l" t="t" r="r" b="b"/>
            <a:pathLst>
              <a:path w="3794084" h="2992331">
                <a:moveTo>
                  <a:pt x="3312171" y="1996"/>
                </a:moveTo>
                <a:cubicBezTo>
                  <a:pt x="3341003" y="12293"/>
                  <a:pt x="3360554" y="60589"/>
                  <a:pt x="3386311" y="88493"/>
                </a:cubicBezTo>
                <a:cubicBezTo>
                  <a:pt x="3410017" y="114175"/>
                  <a:pt x="3441065" y="133554"/>
                  <a:pt x="3460452" y="162634"/>
                </a:cubicBezTo>
                <a:lnTo>
                  <a:pt x="3534593" y="273844"/>
                </a:lnTo>
                <a:lnTo>
                  <a:pt x="3608733" y="385055"/>
                </a:lnTo>
                <a:lnTo>
                  <a:pt x="3633447" y="422126"/>
                </a:lnTo>
                <a:cubicBezTo>
                  <a:pt x="3662856" y="510355"/>
                  <a:pt x="3643710" y="474591"/>
                  <a:pt x="3682874" y="533336"/>
                </a:cubicBezTo>
                <a:lnTo>
                  <a:pt x="3707587" y="607477"/>
                </a:lnTo>
                <a:cubicBezTo>
                  <a:pt x="3711706" y="619834"/>
                  <a:pt x="3712719" y="633709"/>
                  <a:pt x="3719944" y="644547"/>
                </a:cubicBezTo>
                <a:lnTo>
                  <a:pt x="3744657" y="681617"/>
                </a:lnTo>
                <a:cubicBezTo>
                  <a:pt x="3748776" y="698093"/>
                  <a:pt x="3753330" y="714466"/>
                  <a:pt x="3757014" y="731044"/>
                </a:cubicBezTo>
                <a:cubicBezTo>
                  <a:pt x="3768528" y="782855"/>
                  <a:pt x="3772786" y="813316"/>
                  <a:pt x="3781728" y="866969"/>
                </a:cubicBezTo>
                <a:cubicBezTo>
                  <a:pt x="3785847" y="982299"/>
                  <a:pt x="3794084" y="1097555"/>
                  <a:pt x="3794084" y="1212958"/>
                </a:cubicBezTo>
                <a:cubicBezTo>
                  <a:pt x="3794084" y="1316013"/>
                  <a:pt x="3788818" y="1419066"/>
                  <a:pt x="3781728" y="1521877"/>
                </a:cubicBezTo>
                <a:cubicBezTo>
                  <a:pt x="3781224" y="1529183"/>
                  <a:pt x="3763228" y="1597189"/>
                  <a:pt x="3757014" y="1608374"/>
                </a:cubicBezTo>
                <a:cubicBezTo>
                  <a:pt x="3742589" y="1634338"/>
                  <a:pt x="3724063" y="1657801"/>
                  <a:pt x="3707587" y="1682515"/>
                </a:cubicBezTo>
                <a:cubicBezTo>
                  <a:pt x="3685618" y="1715469"/>
                  <a:pt x="3678740" y="1731038"/>
                  <a:pt x="3645803" y="1756655"/>
                </a:cubicBezTo>
                <a:cubicBezTo>
                  <a:pt x="3622358" y="1774890"/>
                  <a:pt x="3595424" y="1788261"/>
                  <a:pt x="3571663" y="1806082"/>
                </a:cubicBezTo>
                <a:cubicBezTo>
                  <a:pt x="3511816" y="1850968"/>
                  <a:pt x="3541774" y="1836641"/>
                  <a:pt x="3485166" y="1855509"/>
                </a:cubicBezTo>
                <a:cubicBezTo>
                  <a:pt x="3303802" y="1976418"/>
                  <a:pt x="3494583" y="1853658"/>
                  <a:pt x="3361598" y="1929650"/>
                </a:cubicBezTo>
                <a:cubicBezTo>
                  <a:pt x="3332468" y="1946296"/>
                  <a:pt x="3301633" y="1972482"/>
                  <a:pt x="3275101" y="1991434"/>
                </a:cubicBezTo>
                <a:cubicBezTo>
                  <a:pt x="3263016" y="2000066"/>
                  <a:pt x="3249439" y="2006640"/>
                  <a:pt x="3238030" y="2016147"/>
                </a:cubicBezTo>
                <a:cubicBezTo>
                  <a:pt x="3224605" y="2027334"/>
                  <a:pt x="3214754" y="2042488"/>
                  <a:pt x="3200960" y="2053217"/>
                </a:cubicBezTo>
                <a:cubicBezTo>
                  <a:pt x="3177515" y="2071452"/>
                  <a:pt x="3147822" y="2081642"/>
                  <a:pt x="3126820" y="2102644"/>
                </a:cubicBezTo>
                <a:cubicBezTo>
                  <a:pt x="3080539" y="2148925"/>
                  <a:pt x="3106328" y="2134189"/>
                  <a:pt x="3052679" y="2152071"/>
                </a:cubicBezTo>
                <a:cubicBezTo>
                  <a:pt x="2967700" y="2208723"/>
                  <a:pt x="3006716" y="2192105"/>
                  <a:pt x="2941468" y="2213855"/>
                </a:cubicBezTo>
                <a:cubicBezTo>
                  <a:pt x="2924992" y="2226212"/>
                  <a:pt x="2908913" y="2239116"/>
                  <a:pt x="2892041" y="2250926"/>
                </a:cubicBezTo>
                <a:cubicBezTo>
                  <a:pt x="2867708" y="2267959"/>
                  <a:pt x="2841662" y="2282532"/>
                  <a:pt x="2817901" y="2300353"/>
                </a:cubicBezTo>
                <a:lnTo>
                  <a:pt x="2719047" y="2374493"/>
                </a:lnTo>
                <a:cubicBezTo>
                  <a:pt x="2702571" y="2386850"/>
                  <a:pt x="2686756" y="2400139"/>
                  <a:pt x="2669620" y="2411563"/>
                </a:cubicBezTo>
                <a:cubicBezTo>
                  <a:pt x="2641941" y="2430016"/>
                  <a:pt x="2607644" y="2451890"/>
                  <a:pt x="2583122" y="2473347"/>
                </a:cubicBezTo>
                <a:cubicBezTo>
                  <a:pt x="2565587" y="2488690"/>
                  <a:pt x="2551230" y="2507431"/>
                  <a:pt x="2533695" y="2522774"/>
                </a:cubicBezTo>
                <a:cubicBezTo>
                  <a:pt x="2518196" y="2536336"/>
                  <a:pt x="2499767" y="2546282"/>
                  <a:pt x="2484268" y="2559844"/>
                </a:cubicBezTo>
                <a:cubicBezTo>
                  <a:pt x="2466733" y="2575187"/>
                  <a:pt x="2452376" y="2593928"/>
                  <a:pt x="2434841" y="2609271"/>
                </a:cubicBezTo>
                <a:cubicBezTo>
                  <a:pt x="2376296" y="2660499"/>
                  <a:pt x="2391301" y="2636042"/>
                  <a:pt x="2323630" y="2683412"/>
                </a:cubicBezTo>
                <a:cubicBezTo>
                  <a:pt x="2302024" y="2698536"/>
                  <a:pt x="2282946" y="2717015"/>
                  <a:pt x="2261847" y="2732839"/>
                </a:cubicBezTo>
                <a:cubicBezTo>
                  <a:pt x="2213676" y="2768968"/>
                  <a:pt x="2232817" y="2749427"/>
                  <a:pt x="2175349" y="2782266"/>
                </a:cubicBezTo>
                <a:cubicBezTo>
                  <a:pt x="2122716" y="2812342"/>
                  <a:pt x="2114127" y="2837733"/>
                  <a:pt x="2039425" y="2856407"/>
                </a:cubicBezTo>
                <a:cubicBezTo>
                  <a:pt x="2022949" y="2860526"/>
                  <a:pt x="2006264" y="2863883"/>
                  <a:pt x="1989998" y="2868763"/>
                </a:cubicBezTo>
                <a:cubicBezTo>
                  <a:pt x="1965046" y="2876248"/>
                  <a:pt x="1940571" y="2885239"/>
                  <a:pt x="1915857" y="2893477"/>
                </a:cubicBezTo>
                <a:cubicBezTo>
                  <a:pt x="1903500" y="2897596"/>
                  <a:pt x="1891423" y="2902675"/>
                  <a:pt x="1878787" y="2905834"/>
                </a:cubicBezTo>
                <a:cubicBezTo>
                  <a:pt x="1862311" y="2909953"/>
                  <a:pt x="1845966" y="2914632"/>
                  <a:pt x="1829360" y="2918190"/>
                </a:cubicBezTo>
                <a:cubicBezTo>
                  <a:pt x="1788288" y="2926991"/>
                  <a:pt x="1745642" y="2929621"/>
                  <a:pt x="1705793" y="2942904"/>
                </a:cubicBezTo>
                <a:cubicBezTo>
                  <a:pt x="1693436" y="2947023"/>
                  <a:pt x="1681437" y="2952435"/>
                  <a:pt x="1668722" y="2955261"/>
                </a:cubicBezTo>
                <a:cubicBezTo>
                  <a:pt x="1611991" y="2967868"/>
                  <a:pt x="1523287" y="2975953"/>
                  <a:pt x="1471014" y="2979974"/>
                </a:cubicBezTo>
                <a:cubicBezTo>
                  <a:pt x="1405177" y="2985038"/>
                  <a:pt x="1339209" y="2988212"/>
                  <a:pt x="1273306" y="2992331"/>
                </a:cubicBezTo>
                <a:lnTo>
                  <a:pt x="1112668" y="2979974"/>
                </a:lnTo>
                <a:lnTo>
                  <a:pt x="741966" y="2955261"/>
                </a:lnTo>
                <a:cubicBezTo>
                  <a:pt x="708894" y="2952255"/>
                  <a:pt x="676063" y="2947023"/>
                  <a:pt x="643111" y="2942904"/>
                </a:cubicBezTo>
                <a:cubicBezTo>
                  <a:pt x="518559" y="2901386"/>
                  <a:pt x="711734" y="2964726"/>
                  <a:pt x="556614" y="2918190"/>
                </a:cubicBezTo>
                <a:cubicBezTo>
                  <a:pt x="531663" y="2910705"/>
                  <a:pt x="504149" y="2907927"/>
                  <a:pt x="482474" y="2893477"/>
                </a:cubicBezTo>
                <a:cubicBezTo>
                  <a:pt x="470117" y="2885239"/>
                  <a:pt x="458441" y="2875875"/>
                  <a:pt x="445403" y="2868763"/>
                </a:cubicBezTo>
                <a:cubicBezTo>
                  <a:pt x="413061" y="2851122"/>
                  <a:pt x="372599" y="2845386"/>
                  <a:pt x="346549" y="2819336"/>
                </a:cubicBezTo>
                <a:cubicBezTo>
                  <a:pt x="334192" y="2806979"/>
                  <a:pt x="320852" y="2795534"/>
                  <a:pt x="309479" y="2782266"/>
                </a:cubicBezTo>
                <a:cubicBezTo>
                  <a:pt x="270225" y="2736469"/>
                  <a:pt x="278983" y="2738789"/>
                  <a:pt x="247695" y="2695769"/>
                </a:cubicBezTo>
                <a:cubicBezTo>
                  <a:pt x="247604" y="2695644"/>
                  <a:pt x="155065" y="2572263"/>
                  <a:pt x="136484" y="2547488"/>
                </a:cubicBezTo>
                <a:lnTo>
                  <a:pt x="99414" y="2498061"/>
                </a:lnTo>
                <a:cubicBezTo>
                  <a:pt x="91176" y="2473347"/>
                  <a:pt x="86351" y="2447220"/>
                  <a:pt x="74701" y="2423920"/>
                </a:cubicBezTo>
                <a:cubicBezTo>
                  <a:pt x="66463" y="2407444"/>
                  <a:pt x="55812" y="2391968"/>
                  <a:pt x="49987" y="2374493"/>
                </a:cubicBezTo>
                <a:cubicBezTo>
                  <a:pt x="29462" y="2312917"/>
                  <a:pt x="23287" y="2263714"/>
                  <a:pt x="12917" y="2201498"/>
                </a:cubicBezTo>
                <a:cubicBezTo>
                  <a:pt x="-4416" y="1976180"/>
                  <a:pt x="-4196" y="2067532"/>
                  <a:pt x="12917" y="1793726"/>
                </a:cubicBezTo>
                <a:cubicBezTo>
                  <a:pt x="18483" y="1704676"/>
                  <a:pt x="23668" y="1642719"/>
                  <a:pt x="37630" y="1558947"/>
                </a:cubicBezTo>
                <a:cubicBezTo>
                  <a:pt x="41083" y="1538230"/>
                  <a:pt x="44461" y="1517425"/>
                  <a:pt x="49987" y="1497163"/>
                </a:cubicBezTo>
                <a:cubicBezTo>
                  <a:pt x="56841" y="1472031"/>
                  <a:pt x="66463" y="1447736"/>
                  <a:pt x="74701" y="1423023"/>
                </a:cubicBezTo>
                <a:cubicBezTo>
                  <a:pt x="78820" y="1410666"/>
                  <a:pt x="79832" y="1396790"/>
                  <a:pt x="87057" y="1385953"/>
                </a:cubicBezTo>
                <a:cubicBezTo>
                  <a:pt x="95295" y="1373596"/>
                  <a:pt x="104403" y="1361777"/>
                  <a:pt x="111771" y="1348882"/>
                </a:cubicBezTo>
                <a:cubicBezTo>
                  <a:pt x="149592" y="1282694"/>
                  <a:pt x="121052" y="1317585"/>
                  <a:pt x="161198" y="1262385"/>
                </a:cubicBezTo>
                <a:cubicBezTo>
                  <a:pt x="342791" y="1012695"/>
                  <a:pt x="153336" y="1267438"/>
                  <a:pt x="284766" y="1114104"/>
                </a:cubicBezTo>
                <a:cubicBezTo>
                  <a:pt x="294431" y="1102828"/>
                  <a:pt x="298978" y="1087535"/>
                  <a:pt x="309479" y="1077034"/>
                </a:cubicBezTo>
                <a:cubicBezTo>
                  <a:pt x="324042" y="1062471"/>
                  <a:pt x="343598" y="1053740"/>
                  <a:pt x="358906" y="1039963"/>
                </a:cubicBezTo>
                <a:cubicBezTo>
                  <a:pt x="384884" y="1016583"/>
                  <a:pt x="405087" y="986793"/>
                  <a:pt x="433047" y="965823"/>
                </a:cubicBezTo>
                <a:cubicBezTo>
                  <a:pt x="506239" y="910929"/>
                  <a:pt x="465333" y="940181"/>
                  <a:pt x="556614" y="879326"/>
                </a:cubicBezTo>
                <a:cubicBezTo>
                  <a:pt x="556619" y="879322"/>
                  <a:pt x="630750" y="829901"/>
                  <a:pt x="630755" y="829898"/>
                </a:cubicBezTo>
                <a:cubicBezTo>
                  <a:pt x="647231" y="821660"/>
                  <a:pt x="663251" y="812441"/>
                  <a:pt x="680182" y="805185"/>
                </a:cubicBezTo>
                <a:cubicBezTo>
                  <a:pt x="692154" y="800054"/>
                  <a:pt x="705602" y="798653"/>
                  <a:pt x="717252" y="792828"/>
                </a:cubicBezTo>
                <a:cubicBezTo>
                  <a:pt x="738734" y="782087"/>
                  <a:pt x="757554" y="766499"/>
                  <a:pt x="779036" y="755758"/>
                </a:cubicBezTo>
                <a:cubicBezTo>
                  <a:pt x="798875" y="745838"/>
                  <a:pt x="821430" y="741816"/>
                  <a:pt x="840820" y="731044"/>
                </a:cubicBezTo>
                <a:cubicBezTo>
                  <a:pt x="858823" y="721042"/>
                  <a:pt x="872783" y="704889"/>
                  <a:pt x="890247" y="693974"/>
                </a:cubicBezTo>
                <a:cubicBezTo>
                  <a:pt x="905867" y="684211"/>
                  <a:pt x="923879" y="678738"/>
                  <a:pt x="939674" y="669261"/>
                </a:cubicBezTo>
                <a:cubicBezTo>
                  <a:pt x="965143" y="653980"/>
                  <a:pt x="987248" y="633117"/>
                  <a:pt x="1013814" y="619834"/>
                </a:cubicBezTo>
                <a:cubicBezTo>
                  <a:pt x="1030290" y="611596"/>
                  <a:pt x="1048252" y="605827"/>
                  <a:pt x="1063241" y="595120"/>
                </a:cubicBezTo>
                <a:cubicBezTo>
                  <a:pt x="1077461" y="584963"/>
                  <a:pt x="1086091" y="568207"/>
                  <a:pt x="1100311" y="558050"/>
                </a:cubicBezTo>
                <a:cubicBezTo>
                  <a:pt x="1125366" y="540153"/>
                  <a:pt x="1185872" y="520023"/>
                  <a:pt x="1211522" y="508623"/>
                </a:cubicBezTo>
                <a:cubicBezTo>
                  <a:pt x="1295239" y="471415"/>
                  <a:pt x="1225208" y="491057"/>
                  <a:pt x="1322733" y="471553"/>
                </a:cubicBezTo>
                <a:cubicBezTo>
                  <a:pt x="1408706" y="437163"/>
                  <a:pt x="1363472" y="453854"/>
                  <a:pt x="1458657" y="422126"/>
                </a:cubicBezTo>
                <a:cubicBezTo>
                  <a:pt x="1458659" y="422125"/>
                  <a:pt x="1532795" y="397413"/>
                  <a:pt x="1532798" y="397412"/>
                </a:cubicBezTo>
                <a:cubicBezTo>
                  <a:pt x="1549274" y="389174"/>
                  <a:pt x="1566232" y="381837"/>
                  <a:pt x="1582225" y="372698"/>
                </a:cubicBezTo>
                <a:cubicBezTo>
                  <a:pt x="1595119" y="365330"/>
                  <a:pt x="1606012" y="354626"/>
                  <a:pt x="1619295" y="347985"/>
                </a:cubicBezTo>
                <a:cubicBezTo>
                  <a:pt x="1639046" y="338110"/>
                  <a:pt x="1687318" y="328550"/>
                  <a:pt x="1705793" y="323271"/>
                </a:cubicBezTo>
                <a:cubicBezTo>
                  <a:pt x="1718317" y="319693"/>
                  <a:pt x="1730297" y="314342"/>
                  <a:pt x="1742863" y="310915"/>
                </a:cubicBezTo>
                <a:cubicBezTo>
                  <a:pt x="1775632" y="301978"/>
                  <a:pt x="1810181" y="298815"/>
                  <a:pt x="1841717" y="286201"/>
                </a:cubicBezTo>
                <a:cubicBezTo>
                  <a:pt x="1874352" y="273147"/>
                  <a:pt x="1906677" y="258815"/>
                  <a:pt x="1940571" y="249131"/>
                </a:cubicBezTo>
                <a:cubicBezTo>
                  <a:pt x="1956900" y="244465"/>
                  <a:pt x="1973392" y="240332"/>
                  <a:pt x="1989998" y="236774"/>
                </a:cubicBezTo>
                <a:cubicBezTo>
                  <a:pt x="2031071" y="227973"/>
                  <a:pt x="2073717" y="225344"/>
                  <a:pt x="2113566" y="212061"/>
                </a:cubicBezTo>
                <a:cubicBezTo>
                  <a:pt x="2125923" y="207942"/>
                  <a:pt x="2137921" y="202530"/>
                  <a:pt x="2150636" y="199704"/>
                </a:cubicBezTo>
                <a:cubicBezTo>
                  <a:pt x="2249825" y="177661"/>
                  <a:pt x="2196576" y="197485"/>
                  <a:pt x="2286560" y="174990"/>
                </a:cubicBezTo>
                <a:cubicBezTo>
                  <a:pt x="2299196" y="171831"/>
                  <a:pt x="2310858" y="165188"/>
                  <a:pt x="2323630" y="162634"/>
                </a:cubicBezTo>
                <a:cubicBezTo>
                  <a:pt x="2352190" y="156922"/>
                  <a:pt x="2381359" y="154820"/>
                  <a:pt x="2410128" y="150277"/>
                </a:cubicBezTo>
                <a:lnTo>
                  <a:pt x="2558409" y="125563"/>
                </a:lnTo>
                <a:cubicBezTo>
                  <a:pt x="2583122" y="121444"/>
                  <a:pt x="2607688" y="116315"/>
                  <a:pt x="2632549" y="113207"/>
                </a:cubicBezTo>
                <a:lnTo>
                  <a:pt x="2731403" y="100850"/>
                </a:lnTo>
                <a:cubicBezTo>
                  <a:pt x="2772545" y="96279"/>
                  <a:pt x="2813849" y="93238"/>
                  <a:pt x="2854971" y="88493"/>
                </a:cubicBezTo>
                <a:cubicBezTo>
                  <a:pt x="2920949" y="80880"/>
                  <a:pt x="2987553" y="76805"/>
                  <a:pt x="3052679" y="63780"/>
                </a:cubicBezTo>
                <a:cubicBezTo>
                  <a:pt x="3073274" y="59661"/>
                  <a:pt x="3094088" y="56517"/>
                  <a:pt x="3114463" y="51423"/>
                </a:cubicBezTo>
                <a:cubicBezTo>
                  <a:pt x="3169608" y="37637"/>
                  <a:pt x="3141744" y="33216"/>
                  <a:pt x="3213317" y="26709"/>
                </a:cubicBezTo>
                <a:cubicBezTo>
                  <a:pt x="3237929" y="24472"/>
                  <a:pt x="3283339" y="-8301"/>
                  <a:pt x="3312171" y="1996"/>
                </a:cubicBezTo>
                <a:close/>
              </a:path>
            </a:pathLst>
          </a:cu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5" name="直線コネクタ 20">
            <a:extLst>
              <a:ext uri="{FF2B5EF4-FFF2-40B4-BE49-F238E27FC236}">
                <a16:creationId xmlns:a16="http://schemas.microsoft.com/office/drawing/2014/main" id="{759B72FF-B625-4B43-ADFB-251DF959E241}"/>
              </a:ext>
            </a:extLst>
          </p:cNvPr>
          <p:cNvCxnSpPr/>
          <p:nvPr/>
        </p:nvCxnSpPr>
        <p:spPr>
          <a:xfrm>
            <a:off x="8825403" y="4980185"/>
            <a:ext cx="2102358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コネクタ 21">
            <a:extLst>
              <a:ext uri="{FF2B5EF4-FFF2-40B4-BE49-F238E27FC236}">
                <a16:creationId xmlns:a16="http://schemas.microsoft.com/office/drawing/2014/main" id="{88A124F1-B91D-D747-90FD-98DA79440092}"/>
              </a:ext>
            </a:extLst>
          </p:cNvPr>
          <p:cNvCxnSpPr/>
          <p:nvPr/>
        </p:nvCxnSpPr>
        <p:spPr>
          <a:xfrm>
            <a:off x="8834542" y="4971043"/>
            <a:ext cx="0" cy="15012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線コネクタ 22">
            <a:extLst>
              <a:ext uri="{FF2B5EF4-FFF2-40B4-BE49-F238E27FC236}">
                <a16:creationId xmlns:a16="http://schemas.microsoft.com/office/drawing/2014/main" id="{D9FC5E2D-EFE4-D945-87C5-B41A4768A066}"/>
              </a:ext>
            </a:extLst>
          </p:cNvPr>
          <p:cNvCxnSpPr/>
          <p:nvPr/>
        </p:nvCxnSpPr>
        <p:spPr>
          <a:xfrm>
            <a:off x="10912524" y="4971043"/>
            <a:ext cx="0" cy="15012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コネクタ 23">
            <a:extLst>
              <a:ext uri="{FF2B5EF4-FFF2-40B4-BE49-F238E27FC236}">
                <a16:creationId xmlns:a16="http://schemas.microsoft.com/office/drawing/2014/main" id="{C68B36AD-43F2-5C42-8F4A-C42595FA4341}"/>
              </a:ext>
            </a:extLst>
          </p:cNvPr>
          <p:cNvCxnSpPr/>
          <p:nvPr/>
        </p:nvCxnSpPr>
        <p:spPr>
          <a:xfrm>
            <a:off x="9876582" y="4971043"/>
            <a:ext cx="0" cy="15012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線コネクタ 24">
            <a:extLst>
              <a:ext uri="{FF2B5EF4-FFF2-40B4-BE49-F238E27FC236}">
                <a16:creationId xmlns:a16="http://schemas.microsoft.com/office/drawing/2014/main" id="{6C10982D-65FE-7348-90A3-510A50A46649}"/>
              </a:ext>
            </a:extLst>
          </p:cNvPr>
          <p:cNvCxnSpPr/>
          <p:nvPr/>
        </p:nvCxnSpPr>
        <p:spPr>
          <a:xfrm>
            <a:off x="10394552" y="4971043"/>
            <a:ext cx="0" cy="15012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線コネクタ 25">
            <a:extLst>
              <a:ext uri="{FF2B5EF4-FFF2-40B4-BE49-F238E27FC236}">
                <a16:creationId xmlns:a16="http://schemas.microsoft.com/office/drawing/2014/main" id="{446FFEC8-70F0-AD43-AFDA-5DE2BFDB0AB3}"/>
              </a:ext>
            </a:extLst>
          </p:cNvPr>
          <p:cNvCxnSpPr/>
          <p:nvPr/>
        </p:nvCxnSpPr>
        <p:spPr>
          <a:xfrm>
            <a:off x="9379936" y="4971043"/>
            <a:ext cx="0" cy="15012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テキスト ボックス 26">
            <a:extLst>
              <a:ext uri="{FF2B5EF4-FFF2-40B4-BE49-F238E27FC236}">
                <a16:creationId xmlns:a16="http://schemas.microsoft.com/office/drawing/2014/main" id="{6B91AD51-BAC1-5D4D-A731-166BB77F792F}"/>
              </a:ext>
            </a:extLst>
          </p:cNvPr>
          <p:cNvSpPr txBox="1"/>
          <p:nvPr/>
        </p:nvSpPr>
        <p:spPr>
          <a:xfrm>
            <a:off x="8706573" y="5084599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0</a:t>
            </a:r>
            <a:endParaRPr kumimoji="1" lang="ja-JP" altLang="en-US" sz="1400"/>
          </a:p>
        </p:txBody>
      </p:sp>
      <p:sp>
        <p:nvSpPr>
          <p:cNvPr id="32" name="テキスト ボックス 27">
            <a:extLst>
              <a:ext uri="{FF2B5EF4-FFF2-40B4-BE49-F238E27FC236}">
                <a16:creationId xmlns:a16="http://schemas.microsoft.com/office/drawing/2014/main" id="{29DA2621-9750-1F44-A162-F0CFC0A59E18}"/>
              </a:ext>
            </a:extLst>
          </p:cNvPr>
          <p:cNvSpPr txBox="1"/>
          <p:nvPr/>
        </p:nvSpPr>
        <p:spPr>
          <a:xfrm>
            <a:off x="9159152" y="5084599"/>
            <a:ext cx="430238" cy="3175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0.5</a:t>
            </a:r>
            <a:endParaRPr kumimoji="1" lang="ja-JP" altLang="en-US" sz="1400"/>
          </a:p>
        </p:txBody>
      </p:sp>
      <p:sp>
        <p:nvSpPr>
          <p:cNvPr id="33" name="テキスト ボックス 28">
            <a:extLst>
              <a:ext uri="{FF2B5EF4-FFF2-40B4-BE49-F238E27FC236}">
                <a16:creationId xmlns:a16="http://schemas.microsoft.com/office/drawing/2014/main" id="{A7CDB017-E321-B842-8F66-F62FFF8D2F30}"/>
              </a:ext>
            </a:extLst>
          </p:cNvPr>
          <p:cNvSpPr txBox="1"/>
          <p:nvPr/>
        </p:nvSpPr>
        <p:spPr>
          <a:xfrm>
            <a:off x="9743732" y="5084599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1</a:t>
            </a:r>
            <a:endParaRPr kumimoji="1" lang="ja-JP" altLang="en-US" sz="1400"/>
          </a:p>
        </p:txBody>
      </p:sp>
      <p:sp>
        <p:nvSpPr>
          <p:cNvPr id="34" name="テキスト ボックス 29">
            <a:extLst>
              <a:ext uri="{FF2B5EF4-FFF2-40B4-BE49-F238E27FC236}">
                <a16:creationId xmlns:a16="http://schemas.microsoft.com/office/drawing/2014/main" id="{B4A01AA8-2A00-4648-A1FB-7F4E0E904D96}"/>
              </a:ext>
            </a:extLst>
          </p:cNvPr>
          <p:cNvSpPr txBox="1"/>
          <p:nvPr/>
        </p:nvSpPr>
        <p:spPr>
          <a:xfrm>
            <a:off x="10198739" y="5087490"/>
            <a:ext cx="430238" cy="3175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1</a:t>
            </a:r>
            <a:r>
              <a:rPr kumimoji="1" lang="en-US" altLang="ja-JP" sz="1400" dirty="0"/>
              <a:t>.5</a:t>
            </a:r>
            <a:endParaRPr kumimoji="1" lang="ja-JP" altLang="en-US" sz="1400"/>
          </a:p>
        </p:txBody>
      </p:sp>
      <p:sp>
        <p:nvSpPr>
          <p:cNvPr id="35" name="テキスト ボックス 30">
            <a:extLst>
              <a:ext uri="{FF2B5EF4-FFF2-40B4-BE49-F238E27FC236}">
                <a16:creationId xmlns:a16="http://schemas.microsoft.com/office/drawing/2014/main" id="{14D6A740-600D-BD45-99D6-E0DBDDEF30DD}"/>
              </a:ext>
            </a:extLst>
          </p:cNvPr>
          <p:cNvSpPr txBox="1"/>
          <p:nvPr/>
        </p:nvSpPr>
        <p:spPr>
          <a:xfrm>
            <a:off x="10776372" y="5088687"/>
            <a:ext cx="610766" cy="3175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2mm</a:t>
            </a:r>
            <a:endParaRPr kumimoji="1" lang="ja-JP" altLang="en-US" sz="1400"/>
          </a:p>
        </p:txBody>
      </p:sp>
    </p:spTree>
    <p:extLst>
      <p:ext uri="{BB962C8B-B14F-4D97-AF65-F5344CB8AC3E}">
        <p14:creationId xmlns:p14="http://schemas.microsoft.com/office/powerpoint/2010/main" val="13373204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3</TotalTime>
  <Words>45</Words>
  <Application>Microsoft Macintosh PowerPoint</Application>
  <PresentationFormat>Widescreen</PresentationFormat>
  <Paragraphs>1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Meiryo UI</vt:lpstr>
      <vt:lpstr>游ゴシック</vt:lpstr>
      <vt:lpstr>游ゴシック Light</vt:lpstr>
      <vt:lpstr>Arial</vt:lpstr>
      <vt:lpstr>Office テーマ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KOU21-391</dc:title>
  <dc:creator>川野 竜太郎</dc:creator>
  <cp:lastModifiedBy>寺井 秀樹</cp:lastModifiedBy>
  <cp:revision>9</cp:revision>
  <dcterms:created xsi:type="dcterms:W3CDTF">2023-07-25T07:46:37Z</dcterms:created>
  <dcterms:modified xsi:type="dcterms:W3CDTF">2023-08-19T06:00:48Z</dcterms:modified>
</cp:coreProperties>
</file>